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E77206-4589-42FB-845C-70DC24971BA7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87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Figure E11. Inflammatory mediators in bronchoalveolar lavage (a,b,d,e) and sputum (c,f) in health and asthm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oncentrations of tryptase (a and d), (b) carboxypeptidase A3 (b and e) in BAL, and sputum of chymase (c and f). Differences are compared by Mann Whitney tests (two groups). P values are for Kruskal-Wallis tests (multiple groups) with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post hoc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Dunn’s compared with health: * P&lt;0·05, ** P&lt;0·01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5B1DEA-E39A-4932-B020-F69C46F1B2B7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33B7C-319C-4124-8CB5-C83BCAB87B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29BD63-017C-4EE3-8A4E-27715075A4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BB928-C54B-4487-905F-7C9B10170E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F7F420-CA28-4F29-8330-E316228C3A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A1D0E-7539-47FF-A910-F319F4E089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89FDF-660F-476F-BC71-D8834E7525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56878B-5274-48F3-A5CA-87BD00EA52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E78F0-0B06-46D3-86F4-68B471475C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69A01F-E8C4-4E9D-A019-E2B725A2C7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B7A71-9A9C-4409-BB02-8F9B811C08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B72A2-A667-4F39-9FF4-BA5712A19F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E90F40-DCDA-4910-A9E7-D6E9DCF6F6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9E5B76-049F-467A-847F-C2558DBA3ECC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385"/>
          <p:cNvGraphicFramePr/>
          <p:nvPr/>
        </p:nvGraphicFramePr>
        <p:xfrm>
          <a:off x="117360" y="3508200"/>
          <a:ext cx="5052960" cy="21542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38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7360" y="3508200"/>
                    <a:ext cx="5052960" cy="2154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Text Box 14"/>
          <p:cNvSpPr/>
          <p:nvPr/>
        </p:nvSpPr>
        <p:spPr>
          <a:xfrm>
            <a:off x="233280" y="371520"/>
            <a:ext cx="829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Inflammatory mediators in BAL (a,  b, d, e) and sputum (c, f) in health and asthm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250920" y="836640"/>
            <a:ext cx="37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4"/>
          <p:cNvSpPr/>
          <p:nvPr/>
        </p:nvSpPr>
        <p:spPr>
          <a:xfrm>
            <a:off x="2556000" y="841320"/>
            <a:ext cx="37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4"/>
          <p:cNvSpPr/>
          <p:nvPr/>
        </p:nvSpPr>
        <p:spPr>
          <a:xfrm>
            <a:off x="6269040" y="841320"/>
            <a:ext cx="96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put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Object 386"/>
          <p:cNvGraphicFramePr/>
          <p:nvPr/>
        </p:nvGraphicFramePr>
        <p:xfrm>
          <a:off x="179280" y="1181160"/>
          <a:ext cx="4916520" cy="17841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5" name="Object 38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79280" y="1181160"/>
                    <a:ext cx="4916520" cy="1784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6" name="Object 387"/>
          <p:cNvGraphicFramePr/>
          <p:nvPr/>
        </p:nvGraphicFramePr>
        <p:xfrm>
          <a:off x="6243480" y="3619440"/>
          <a:ext cx="2329200" cy="17542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7" name="Object 38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243480" y="3619440"/>
                    <a:ext cx="2329200" cy="1754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8" name="Object 388"/>
          <p:cNvGraphicFramePr/>
          <p:nvPr/>
        </p:nvGraphicFramePr>
        <p:xfrm>
          <a:off x="6240600" y="1298520"/>
          <a:ext cx="2363760" cy="15256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9" name="Object 388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6240600" y="1298520"/>
                    <a:ext cx="2363760" cy="1525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" name="Text Box 14"/>
          <p:cNvSpPr/>
          <p:nvPr/>
        </p:nvSpPr>
        <p:spPr>
          <a:xfrm>
            <a:off x="250920" y="3213000"/>
            <a:ext cx="28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4"/>
          <p:cNvSpPr/>
          <p:nvPr/>
        </p:nvSpPr>
        <p:spPr>
          <a:xfrm>
            <a:off x="2556000" y="321804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4"/>
          <p:cNvSpPr/>
          <p:nvPr/>
        </p:nvSpPr>
        <p:spPr>
          <a:xfrm>
            <a:off x="6227640" y="3213000"/>
            <a:ext cx="119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Sput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96"/>
          <p:cNvSpPr/>
          <p:nvPr/>
        </p:nvSpPr>
        <p:spPr>
          <a:xfrm>
            <a:off x="6592320" y="530064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96"/>
          <p:cNvSpPr/>
          <p:nvPr/>
        </p:nvSpPr>
        <p:spPr>
          <a:xfrm>
            <a:off x="7212240" y="530208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96"/>
          <p:cNvSpPr/>
          <p:nvPr/>
        </p:nvSpPr>
        <p:spPr>
          <a:xfrm>
            <a:off x="7612560" y="53020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96"/>
          <p:cNvSpPr/>
          <p:nvPr/>
        </p:nvSpPr>
        <p:spPr>
          <a:xfrm>
            <a:off x="7980840" y="530208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96"/>
          <p:cNvSpPr/>
          <p:nvPr/>
        </p:nvSpPr>
        <p:spPr>
          <a:xfrm>
            <a:off x="3063240" y="530064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96"/>
          <p:cNvSpPr/>
          <p:nvPr/>
        </p:nvSpPr>
        <p:spPr>
          <a:xfrm>
            <a:off x="3683880" y="530208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96"/>
          <p:cNvSpPr/>
          <p:nvPr/>
        </p:nvSpPr>
        <p:spPr>
          <a:xfrm>
            <a:off x="4084920" y="53020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96"/>
          <p:cNvSpPr/>
          <p:nvPr/>
        </p:nvSpPr>
        <p:spPr>
          <a:xfrm>
            <a:off x="4452480" y="530208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96"/>
          <p:cNvSpPr/>
          <p:nvPr/>
        </p:nvSpPr>
        <p:spPr>
          <a:xfrm>
            <a:off x="626400" y="530064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96"/>
          <p:cNvSpPr/>
          <p:nvPr/>
        </p:nvSpPr>
        <p:spPr>
          <a:xfrm>
            <a:off x="1246320" y="530208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96"/>
          <p:cNvSpPr/>
          <p:nvPr/>
        </p:nvSpPr>
        <p:spPr>
          <a:xfrm>
            <a:off x="1647360" y="53020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96"/>
          <p:cNvSpPr/>
          <p:nvPr/>
        </p:nvSpPr>
        <p:spPr>
          <a:xfrm>
            <a:off x="2016000" y="530208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96"/>
          <p:cNvSpPr/>
          <p:nvPr/>
        </p:nvSpPr>
        <p:spPr>
          <a:xfrm>
            <a:off x="3215520" y="263700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96"/>
          <p:cNvSpPr/>
          <p:nvPr/>
        </p:nvSpPr>
        <p:spPr>
          <a:xfrm>
            <a:off x="4150800" y="263844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sthm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96"/>
          <p:cNvSpPr/>
          <p:nvPr/>
        </p:nvSpPr>
        <p:spPr>
          <a:xfrm>
            <a:off x="831240" y="263700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96"/>
          <p:cNvSpPr/>
          <p:nvPr/>
        </p:nvSpPr>
        <p:spPr>
          <a:xfrm>
            <a:off x="1794960" y="263844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sthm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96"/>
          <p:cNvSpPr/>
          <p:nvPr/>
        </p:nvSpPr>
        <p:spPr>
          <a:xfrm>
            <a:off x="6807960" y="264312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96"/>
          <p:cNvSpPr/>
          <p:nvPr/>
        </p:nvSpPr>
        <p:spPr>
          <a:xfrm>
            <a:off x="7743240" y="264492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sthm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75"/>
          <p:cNvSpPr/>
          <p:nvPr/>
        </p:nvSpPr>
        <p:spPr>
          <a:xfrm>
            <a:off x="1128600" y="3776760"/>
            <a:ext cx="498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75"/>
          <p:cNvSpPr/>
          <p:nvPr/>
        </p:nvSpPr>
        <p:spPr>
          <a:xfrm>
            <a:off x="2119320" y="3770280"/>
            <a:ext cx="498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75"/>
          <p:cNvSpPr/>
          <p:nvPr/>
        </p:nvSpPr>
        <p:spPr>
          <a:xfrm>
            <a:off x="3568680" y="3770280"/>
            <a:ext cx="498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75"/>
          <p:cNvSpPr/>
          <p:nvPr/>
        </p:nvSpPr>
        <p:spPr>
          <a:xfrm>
            <a:off x="4010040" y="3770280"/>
            <a:ext cx="498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75"/>
          <p:cNvSpPr/>
          <p:nvPr/>
        </p:nvSpPr>
        <p:spPr>
          <a:xfrm>
            <a:off x="8034480" y="3770280"/>
            <a:ext cx="498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5-02-09T14:51:25Z</dcterms:modified>
  <cp:revision>280</cp:revision>
  <dc:subject/>
  <dc:title>PowerPoint Presentation</dc:title>
</cp:coreProperties>
</file>